
<file path=[Content_Types].xml><?xml version="1.0" encoding="utf-8"?>
<Types xmlns="http://schemas.openxmlformats.org/package/2006/content-types">
  <Default Extension="bin" ContentType="application/vnd.openxmlformats-officedocument.oleObject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CC0000"/>
    <a:srgbClr val="FF33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111" d="100"/>
          <a:sy n="111" d="100"/>
        </p:scale>
        <p:origin x="594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Abbie Stark (Aneurin Bevan UHB - Learning Disabilities)" userId="dba745bf-c3eb-4042-85bc-0d2b69f16cc5" providerId="ADAL" clId="{9ED371CD-9852-4D36-A2C3-B31A49BAA17F}"/>
    <pc:docChg chg="undo redo custSel addSld modSld">
      <pc:chgData name="Abbie Stark (Aneurin Bevan UHB - Learning Disabilities)" userId="dba745bf-c3eb-4042-85bc-0d2b69f16cc5" providerId="ADAL" clId="{9ED371CD-9852-4D36-A2C3-B31A49BAA17F}" dt="2025-01-14T12:21:55.423" v="79" actId="167"/>
      <pc:docMkLst>
        <pc:docMk/>
      </pc:docMkLst>
      <pc:sldChg chg="addSp delSp modSp add mod">
        <pc:chgData name="Abbie Stark (Aneurin Bevan UHB - Learning Disabilities)" userId="dba745bf-c3eb-4042-85bc-0d2b69f16cc5" providerId="ADAL" clId="{9ED371CD-9852-4D36-A2C3-B31A49BAA17F}" dt="2025-01-14T12:16:11.004" v="17"/>
        <pc:sldMkLst>
          <pc:docMk/>
          <pc:sldMk cId="2281966106" sldId="257"/>
        </pc:sldMkLst>
      </pc:sldChg>
      <pc:sldChg chg="addSp delSp modSp new mod">
        <pc:chgData name="Abbie Stark (Aneurin Bevan UHB - Learning Disabilities)" userId="dba745bf-c3eb-4042-85bc-0d2b69f16cc5" providerId="ADAL" clId="{9ED371CD-9852-4D36-A2C3-B31A49BAA17F}" dt="2025-01-14T12:21:55.423" v="79" actId="167"/>
        <pc:sldMkLst>
          <pc:docMk/>
          <pc:sldMk cId="2914486076" sldId="258"/>
        </pc:sldMkLst>
      </pc:sldChg>
    </pc:docChg>
  </pc:docChgLst>
  <pc:docChgLst>
    <pc:chgData name="Abbie Stark (Aneurin Bevan UHB - Learning Disabilities)" userId="dba745bf-c3eb-4042-85bc-0d2b69f16cc5" providerId="ADAL" clId="{271E6C83-320C-4E25-9E8D-80588DA06B73}"/>
    <pc:docChg chg="delSld">
      <pc:chgData name="Abbie Stark (Aneurin Bevan UHB - Learning Disabilities)" userId="dba745bf-c3eb-4042-85bc-0d2b69f16cc5" providerId="ADAL" clId="{271E6C83-320C-4E25-9E8D-80588DA06B73}" dt="2025-04-16T10:05:20.076" v="1" actId="2696"/>
      <pc:docMkLst>
        <pc:docMk/>
      </pc:docMkLst>
      <pc:sldChg chg="del">
        <pc:chgData name="Abbie Stark (Aneurin Bevan UHB - Learning Disabilities)" userId="dba745bf-c3eb-4042-85bc-0d2b69f16cc5" providerId="ADAL" clId="{271E6C83-320C-4E25-9E8D-80588DA06B73}" dt="2025-04-16T10:05:18.363" v="0" actId="2696"/>
        <pc:sldMkLst>
          <pc:docMk/>
          <pc:sldMk cId="1941092958" sldId="256"/>
        </pc:sldMkLst>
      </pc:sldChg>
      <pc:sldChg chg="del">
        <pc:chgData name="Abbie Stark (Aneurin Bevan UHB - Learning Disabilities)" userId="dba745bf-c3eb-4042-85bc-0d2b69f16cc5" providerId="ADAL" clId="{271E6C83-320C-4E25-9E8D-80588DA06B73}" dt="2025-04-16T10:05:20.076" v="1" actId="2696"/>
        <pc:sldMkLst>
          <pc:docMk/>
          <pc:sldMk cId="2281966106" sldId="257"/>
        </pc:sldMkLst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oleObject" Target="../embeddings/oleObject1.bin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GB"/>
              <a:t>Mean</a:t>
            </a:r>
            <a:r>
              <a:rPr lang="en-GB" baseline="0"/>
              <a:t> depression scores for the CBT and control group across time</a:t>
            </a:r>
            <a:endParaRPr lang="en-GB"/>
          </a:p>
        </c:rich>
      </c:tx>
      <c:layout>
        <c:manualLayout>
          <c:xMode val="edge"/>
          <c:yMode val="edge"/>
          <c:x val="0.17431835067558235"/>
          <c:y val="4.1459369817578771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GB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'[PHQ graph and clinical change ITT and Completer.xlsx]Sheet1'!$A$4</c:f>
              <c:strCache>
                <c:ptCount val="1"/>
                <c:pt idx="0">
                  <c:v>CBT group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cat>
            <c:strRef>
              <c:f>'[PHQ graph and clinical change ITT and Completer.xlsx]Sheet1'!$B$2:$D$3</c:f>
              <c:strCache>
                <c:ptCount val="3"/>
                <c:pt idx="0">
                  <c:v>Baseline</c:v>
                </c:pt>
                <c:pt idx="1">
                  <c:v>Post-intervention</c:v>
                </c:pt>
                <c:pt idx="2">
                  <c:v>Follow-up</c:v>
                </c:pt>
              </c:strCache>
            </c:strRef>
          </c:cat>
          <c:val>
            <c:numRef>
              <c:f>'[PHQ graph and clinical change ITT and Completer.xlsx]Sheet1'!$B$4:$D$4</c:f>
              <c:numCache>
                <c:formatCode>General</c:formatCode>
                <c:ptCount val="3"/>
                <c:pt idx="0">
                  <c:v>13.57</c:v>
                </c:pt>
                <c:pt idx="1">
                  <c:v>9.67</c:v>
                </c:pt>
                <c:pt idx="2">
                  <c:v>8.4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5160-45D0-9427-171D5CB5D6DC}"/>
            </c:ext>
          </c:extLst>
        </c:ser>
        <c:ser>
          <c:idx val="1"/>
          <c:order val="1"/>
          <c:tx>
            <c:strRef>
              <c:f>'[PHQ graph and clinical change ITT and Completer.xlsx]Sheet1'!$A$5</c:f>
              <c:strCache>
                <c:ptCount val="1"/>
                <c:pt idx="0">
                  <c:v>Control group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cat>
            <c:strRef>
              <c:f>'[PHQ graph and clinical change ITT and Completer.xlsx]Sheet1'!$B$2:$D$3</c:f>
              <c:strCache>
                <c:ptCount val="3"/>
                <c:pt idx="0">
                  <c:v>Baseline</c:v>
                </c:pt>
                <c:pt idx="1">
                  <c:v>Post-intervention</c:v>
                </c:pt>
                <c:pt idx="2">
                  <c:v>Follow-up</c:v>
                </c:pt>
              </c:strCache>
            </c:strRef>
          </c:cat>
          <c:val>
            <c:numRef>
              <c:f>'[PHQ graph and clinical change ITT and Completer.xlsx]Sheet1'!$B$5:$D$5</c:f>
              <c:numCache>
                <c:formatCode>General</c:formatCode>
                <c:ptCount val="3"/>
                <c:pt idx="0">
                  <c:v>13.21</c:v>
                </c:pt>
                <c:pt idx="1">
                  <c:v>11.91</c:v>
                </c:pt>
                <c:pt idx="2">
                  <c:v>11.2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5160-45D0-9427-171D5CB5D6DC}"/>
            </c:ext>
          </c:extLst>
        </c:ser>
        <c:ser>
          <c:idx val="5"/>
          <c:order val="5"/>
          <c:tx>
            <c:strRef>
              <c:f>'[PHQ graph and clinical change ITT and Completer.xlsx]Sheet1'!$A$9</c:f>
              <c:strCache>
                <c:ptCount val="1"/>
              </c:strCache>
            </c:strRef>
          </c:tx>
          <c:spPr>
            <a:ln w="28575" cap="rnd">
              <a:solidFill>
                <a:schemeClr val="accent6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/>
              </a:solidFill>
              <a:ln w="9525">
                <a:solidFill>
                  <a:schemeClr val="accent6"/>
                </a:solidFill>
              </a:ln>
              <a:effectLst/>
            </c:spPr>
          </c:marker>
          <c:cat>
            <c:strRef>
              <c:f>'[PHQ graph and clinical change ITT and Completer.xlsx]Sheet1'!$B$2:$D$3</c:f>
              <c:strCache>
                <c:ptCount val="3"/>
                <c:pt idx="0">
                  <c:v>Baseline</c:v>
                </c:pt>
                <c:pt idx="1">
                  <c:v>Post-intervention</c:v>
                </c:pt>
                <c:pt idx="2">
                  <c:v>Follow-up</c:v>
                </c:pt>
              </c:strCache>
            </c:strRef>
          </c:cat>
          <c:val>
            <c:numRef>
              <c:f>'[PHQ graph and clinical change ITT and Completer.xlsx]Sheet1'!$B$9:$D$9</c:f>
              <c:numCache>
                <c:formatCode>General</c:formatCode>
                <c:ptCount val="3"/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5160-45D0-9427-171D5CB5D6DC}"/>
            </c:ext>
          </c:extLst>
        </c:ser>
        <c:ser>
          <c:idx val="6"/>
          <c:order val="6"/>
          <c:tx>
            <c:strRef>
              <c:f>'[PHQ graph and clinical change ITT and Completer.xlsx]Sheet1'!$A$10</c:f>
              <c:strCache>
                <c:ptCount val="1"/>
                <c:pt idx="0">
                  <c:v>CBT group ITT</c:v>
                </c:pt>
              </c:strCache>
            </c:strRef>
          </c:tx>
          <c:spPr>
            <a:ln w="28575" cap="rnd">
              <a:solidFill>
                <a:schemeClr val="accent1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60000"/>
                </a:schemeClr>
              </a:solidFill>
              <a:ln w="9525">
                <a:solidFill>
                  <a:schemeClr val="accent1">
                    <a:lumMod val="60000"/>
                  </a:schemeClr>
                </a:solidFill>
              </a:ln>
              <a:effectLst/>
            </c:spPr>
          </c:marker>
          <c:cat>
            <c:strRef>
              <c:f>'[PHQ graph and clinical change ITT and Completer.xlsx]Sheet1'!$B$2:$D$3</c:f>
              <c:strCache>
                <c:ptCount val="3"/>
                <c:pt idx="0">
                  <c:v>Baseline</c:v>
                </c:pt>
                <c:pt idx="1">
                  <c:v>Post-intervention</c:v>
                </c:pt>
                <c:pt idx="2">
                  <c:v>Follow-up</c:v>
                </c:pt>
              </c:strCache>
            </c:strRef>
          </c:cat>
          <c:val>
            <c:numRef>
              <c:f>'[PHQ graph and clinical change ITT and Completer.xlsx]Sheet1'!$B$10:$D$10</c:f>
              <c:numCache>
                <c:formatCode>0.00</c:formatCode>
                <c:ptCount val="3"/>
                <c:pt idx="0">
                  <c:v>13.15</c:v>
                </c:pt>
                <c:pt idx="1">
                  <c:v>8.82</c:v>
                </c:pt>
                <c:pt idx="2">
                  <c:v>8.449999999999999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5160-45D0-9427-171D5CB5D6DC}"/>
            </c:ext>
          </c:extLst>
        </c:ser>
        <c:ser>
          <c:idx val="7"/>
          <c:order val="7"/>
          <c:tx>
            <c:strRef>
              <c:f>'[PHQ graph and clinical change ITT and Completer.xlsx]Sheet1'!$A$11</c:f>
              <c:strCache>
                <c:ptCount val="1"/>
                <c:pt idx="0">
                  <c:v>Control group ITT</c:v>
                </c:pt>
              </c:strCache>
            </c:strRef>
          </c:tx>
          <c:spPr>
            <a:ln w="28575" cap="rnd">
              <a:solidFill>
                <a:schemeClr val="accent2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60000"/>
                </a:schemeClr>
              </a:solidFill>
              <a:ln w="9525">
                <a:solidFill>
                  <a:schemeClr val="accent2">
                    <a:lumMod val="60000"/>
                  </a:schemeClr>
                </a:solidFill>
              </a:ln>
              <a:effectLst/>
            </c:spPr>
          </c:marker>
          <c:cat>
            <c:strRef>
              <c:f>'[PHQ graph and clinical change ITT and Completer.xlsx]Sheet1'!$B$2:$D$3</c:f>
              <c:strCache>
                <c:ptCount val="3"/>
                <c:pt idx="0">
                  <c:v>Baseline</c:v>
                </c:pt>
                <c:pt idx="1">
                  <c:v>Post-intervention</c:v>
                </c:pt>
                <c:pt idx="2">
                  <c:v>Follow-up</c:v>
                </c:pt>
              </c:strCache>
            </c:strRef>
          </c:cat>
          <c:val>
            <c:numRef>
              <c:f>'[PHQ graph and clinical change ITT and Completer.xlsx]Sheet1'!$B$11:$D$11</c:f>
              <c:numCache>
                <c:formatCode>General</c:formatCode>
                <c:ptCount val="3"/>
                <c:pt idx="0">
                  <c:v>13.14</c:v>
                </c:pt>
                <c:pt idx="1">
                  <c:v>11.74</c:v>
                </c:pt>
                <c:pt idx="2">
                  <c:v>10.8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5160-45D0-9427-171D5CB5D6D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559121680"/>
        <c:axId val="559113520"/>
        <c:extLst>
          <c:ext xmlns:c15="http://schemas.microsoft.com/office/drawing/2012/chart" uri="{02D57815-91ED-43cb-92C2-25804820EDAC}">
            <c15:filteredLineSeries>
              <c15:ser>
                <c:idx val="2"/>
                <c:order val="2"/>
                <c:tx>
                  <c:strRef>
                    <c:extLst>
                      <c:ext uri="{02D57815-91ED-43cb-92C2-25804820EDAC}">
                        <c15:formulaRef>
                          <c15:sqref>'[PHQ graph and clinical change ITT and Completer.xlsx]Sheet1'!$A$6</c15:sqref>
                        </c15:formulaRef>
                      </c:ext>
                    </c:extLst>
                    <c:strCache>
                      <c:ptCount val="1"/>
                    </c:strCache>
                  </c:strRef>
                </c:tx>
                <c:spPr>
                  <a:ln w="28575" cap="rnd">
                    <a:solidFill>
                      <a:schemeClr val="accent3"/>
                    </a:solidFill>
                    <a:round/>
                  </a:ln>
                  <a:effectLst/>
                </c:spPr>
                <c:marker>
                  <c:symbol val="circle"/>
                  <c:size val="5"/>
                  <c:spPr>
                    <a:solidFill>
                      <a:schemeClr val="accent3"/>
                    </a:solidFill>
                    <a:ln w="9525">
                      <a:solidFill>
                        <a:schemeClr val="accent3"/>
                      </a:solidFill>
                    </a:ln>
                    <a:effectLst/>
                  </c:spPr>
                </c:marker>
                <c:cat>
                  <c:strRef>
                    <c:extLst>
                      <c:ext uri="{02D57815-91ED-43cb-92C2-25804820EDAC}">
                        <c15:formulaRef>
                          <c15:sqref>'[PHQ graph and clinical change ITT and Completer.xlsx]Sheet1'!$B$2:$D$3</c15:sqref>
                        </c15:formulaRef>
                      </c:ext>
                    </c:extLst>
                    <c:strCache>
                      <c:ptCount val="3"/>
                      <c:pt idx="0">
                        <c:v>Baseline</c:v>
                      </c:pt>
                      <c:pt idx="1">
                        <c:v>Post-intervention</c:v>
                      </c:pt>
                      <c:pt idx="2">
                        <c:v>Follow-up</c:v>
                      </c:pt>
                    </c:strCache>
                  </c:strRef>
                </c:cat>
                <c:val>
                  <c:numRef>
                    <c:extLst>
                      <c:ext uri="{02D57815-91ED-43cb-92C2-25804820EDAC}">
                        <c15:formulaRef>
                          <c15:sqref>'[PHQ graph and clinical change ITT and Completer.xlsx]Sheet1'!$B$6:$D$6</c15:sqref>
                        </c15:formulaRef>
                      </c:ext>
                    </c:extLst>
                    <c:numCache>
                      <c:formatCode>General</c:formatCode>
                      <c:ptCount val="3"/>
                    </c:numCache>
                  </c:numRef>
                </c:val>
                <c:smooth val="0"/>
                <c:extLst>
                  <c:ext xmlns:c16="http://schemas.microsoft.com/office/drawing/2014/chart" uri="{C3380CC4-5D6E-409C-BE32-E72D297353CC}">
                    <c16:uniqueId val="{00000005-5160-45D0-9427-171D5CB5D6DC}"/>
                  </c:ext>
                </c:extLst>
              </c15:ser>
            </c15:filteredLineSeries>
            <c15:filteredLineSeries>
              <c15:ser>
                <c:idx val="3"/>
                <c:order val="3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[PHQ graph and clinical change ITT and Completer.xlsx]Sheet1'!$A$7</c15:sqref>
                        </c15:formulaRef>
                      </c:ext>
                    </c:extLst>
                    <c:strCache>
                      <c:ptCount val="1"/>
                      <c:pt idx="0">
                        <c:v>SD: CBT</c:v>
                      </c:pt>
                    </c:strCache>
                  </c:strRef>
                </c:tx>
                <c:spPr>
                  <a:ln w="28575" cap="rnd">
                    <a:solidFill>
                      <a:schemeClr val="accent4"/>
                    </a:solidFill>
                    <a:round/>
                  </a:ln>
                  <a:effectLst/>
                </c:spPr>
                <c:marker>
                  <c:symbol val="circle"/>
                  <c:size val="5"/>
                  <c:spPr>
                    <a:solidFill>
                      <a:schemeClr val="accent4"/>
                    </a:solidFill>
                    <a:ln w="9525">
                      <a:solidFill>
                        <a:schemeClr val="accent4"/>
                      </a:solidFill>
                    </a:ln>
                    <a:effectLst/>
                  </c:spPr>
                </c:marker>
                <c:cat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[PHQ graph and clinical change ITT and Completer.xlsx]Sheet1'!$B$2:$D$3</c15:sqref>
                        </c15:formulaRef>
                      </c:ext>
                    </c:extLst>
                    <c:strCache>
                      <c:ptCount val="3"/>
                      <c:pt idx="0">
                        <c:v>Baseline</c:v>
                      </c:pt>
                      <c:pt idx="1">
                        <c:v>Post-intervention</c:v>
                      </c:pt>
                      <c:pt idx="2">
                        <c:v>Follow-up</c:v>
                      </c:pt>
                    </c:strCache>
                  </c:strRef>
                </c:cat>
                <c: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[PHQ graph and clinical change ITT and Completer.xlsx]Sheet1'!$B$7:$D$7</c15:sqref>
                        </c15:formulaRef>
                      </c:ext>
                    </c:extLst>
                    <c:numCache>
                      <c:formatCode>General</c:formatCode>
                      <c:ptCount val="3"/>
                      <c:pt idx="0">
                        <c:v>4.8099999999999996</c:v>
                      </c:pt>
                      <c:pt idx="1">
                        <c:v>5.03</c:v>
                      </c:pt>
                      <c:pt idx="2">
                        <c:v>4.32</c:v>
                      </c:pt>
                    </c:numCache>
                  </c:numRef>
                </c: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06-5160-45D0-9427-171D5CB5D6DC}"/>
                  </c:ext>
                </c:extLst>
              </c15:ser>
            </c15:filteredLineSeries>
            <c15:filteredLineSeries>
              <c15:ser>
                <c:idx val="4"/>
                <c:order val="4"/>
                <c:tx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[PHQ graph and clinical change ITT and Completer.xlsx]Sheet1'!$A$8</c15:sqref>
                        </c15:formulaRef>
                      </c:ext>
                    </c:extLst>
                    <c:strCache>
                      <c:ptCount val="1"/>
                      <c:pt idx="0">
                        <c:v>Control</c:v>
                      </c:pt>
                    </c:strCache>
                  </c:strRef>
                </c:tx>
                <c:spPr>
                  <a:ln w="28575" cap="rnd">
                    <a:solidFill>
                      <a:schemeClr val="accent5"/>
                    </a:solidFill>
                    <a:round/>
                  </a:ln>
                  <a:effectLst/>
                </c:spPr>
                <c:marker>
                  <c:symbol val="circle"/>
                  <c:size val="5"/>
                  <c:spPr>
                    <a:solidFill>
                      <a:schemeClr val="accent5"/>
                    </a:solidFill>
                    <a:ln w="9525">
                      <a:solidFill>
                        <a:schemeClr val="accent5"/>
                      </a:solidFill>
                    </a:ln>
                    <a:effectLst/>
                  </c:spPr>
                </c:marker>
                <c:cat>
                  <c:str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[PHQ graph and clinical change ITT and Completer.xlsx]Sheet1'!$B$2:$D$3</c15:sqref>
                        </c15:formulaRef>
                      </c:ext>
                    </c:extLst>
                    <c:strCache>
                      <c:ptCount val="3"/>
                      <c:pt idx="0">
                        <c:v>Baseline</c:v>
                      </c:pt>
                      <c:pt idx="1">
                        <c:v>Post-intervention</c:v>
                      </c:pt>
                      <c:pt idx="2">
                        <c:v>Follow-up</c:v>
                      </c:pt>
                    </c:strCache>
                  </c:strRef>
                </c:cat>
                <c:val>
                  <c:numRef>
                    <c:extLst xmlns:c15="http://schemas.microsoft.com/office/drawing/2012/chart">
                      <c:ext xmlns:c15="http://schemas.microsoft.com/office/drawing/2012/chart" uri="{02D57815-91ED-43cb-92C2-25804820EDAC}">
                        <c15:formulaRef>
                          <c15:sqref>'[PHQ graph and clinical change ITT and Completer.xlsx]Sheet1'!$B$8:$D$8</c15:sqref>
                        </c15:formulaRef>
                      </c:ext>
                    </c:extLst>
                    <c:numCache>
                      <c:formatCode>General</c:formatCode>
                      <c:ptCount val="3"/>
                      <c:pt idx="0">
                        <c:v>5.57</c:v>
                      </c:pt>
                      <c:pt idx="1">
                        <c:v>6.18</c:v>
                      </c:pt>
                      <c:pt idx="2">
                        <c:v>6.18</c:v>
                      </c:pt>
                    </c:numCache>
                  </c:numRef>
                </c:val>
                <c:smooth val="0"/>
                <c:extLst xmlns:c15="http://schemas.microsoft.com/office/drawing/2012/chart">
                  <c:ext xmlns:c16="http://schemas.microsoft.com/office/drawing/2014/chart" uri="{C3380CC4-5D6E-409C-BE32-E72D297353CC}">
                    <c16:uniqueId val="{00000007-5160-45D0-9427-171D5CB5D6DC}"/>
                  </c:ext>
                </c:extLst>
              </c15:ser>
            </c15:filteredLineSeries>
          </c:ext>
        </c:extLst>
      </c:lineChart>
      <c:catAx>
        <c:axId val="55912168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59113520"/>
        <c:crosses val="autoZero"/>
        <c:auto val="1"/>
        <c:lblAlgn val="ctr"/>
        <c:lblOffset val="100"/>
        <c:noMultiLvlLbl val="0"/>
      </c:catAx>
      <c:valAx>
        <c:axId val="55911352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55912168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egendEntry>
        <c:idx val="2"/>
        <c:delete val="1"/>
      </c:legendEntry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48CEF9B-25AF-E2F1-6CC0-72493187AA5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CE28514-6EEC-5907-43C5-34655217855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EA6853C-29E5-C772-D8B5-C1845BD9DA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3D8F94-3C42-4A5D-9001-2E53EE8BFA5E}" type="datetimeFigureOut">
              <a:rPr lang="en-GB" smtClean="0"/>
              <a:t>16/04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EE055BD-066E-48C5-6581-91C2F4392A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13B27F1-919C-C904-067D-E8AEAE2AAC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CE04F2-B788-495D-8993-0CEE5099057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290995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33E6B6A-0FA5-1411-4760-868DE6D4745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40C3944-6E21-F90D-9A87-0DE6DD9B01E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5D751C0-7343-ECCE-9177-119E27ACE9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3D8F94-3C42-4A5D-9001-2E53EE8BFA5E}" type="datetimeFigureOut">
              <a:rPr lang="en-GB" smtClean="0"/>
              <a:t>16/04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9E46430-F069-1772-BE68-E687A6B484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696FE29-0868-A713-24BB-1D860BF411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CE04F2-B788-495D-8993-0CEE5099057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123967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C09ADD8-7430-E138-1F14-5C27D8C8336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26A6A7E-09C4-4093-F47F-EA307D30518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CCDF871-FC06-7C00-5C56-811B61686D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3D8F94-3C42-4A5D-9001-2E53EE8BFA5E}" type="datetimeFigureOut">
              <a:rPr lang="en-GB" smtClean="0"/>
              <a:t>16/04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6FB2FE3-E9B6-C90D-F254-DF77556A77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E91D11B-1F48-620F-2A2B-1558EAF636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CE04F2-B788-495D-8993-0CEE5099057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012111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407682D-9761-B48A-FD60-79A4EF2596D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E34D4B6-2452-942A-278C-F20554A2354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68E1833-68F4-B294-FACF-1C9252AF3C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3D8F94-3C42-4A5D-9001-2E53EE8BFA5E}" type="datetimeFigureOut">
              <a:rPr lang="en-GB" smtClean="0"/>
              <a:t>16/04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23F66C3-6583-8AAE-46B9-DBB6B89F75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4F876F4-3139-2A92-3D11-1D8DC2D915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CE04F2-B788-495D-8993-0CEE5099057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124016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727A1BD-A92C-C53A-3523-7135C772E3B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765BE13-4D10-B678-707D-CA21C0FB4D6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CB2F8DC-3976-D3CD-BD37-3BE345327A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3D8F94-3C42-4A5D-9001-2E53EE8BFA5E}" type="datetimeFigureOut">
              <a:rPr lang="en-GB" smtClean="0"/>
              <a:t>16/04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C513181-E700-4F9E-20FA-90586A4552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F3737F6-2A4F-214C-6292-92506C8638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CE04F2-B788-495D-8993-0CEE5099057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798245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71D3220-4537-3B39-7FD3-2C41F77DB8A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DF21C64-319F-F509-6A52-0A70D623D67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12D27C1-25A3-337E-FEC7-C66340322D3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4578C36-DCD1-2C62-EA24-5613DC5D5B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3D8F94-3C42-4A5D-9001-2E53EE8BFA5E}" type="datetimeFigureOut">
              <a:rPr lang="en-GB" smtClean="0"/>
              <a:t>16/04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EBCF69F-D69D-E658-DA19-9298DDFB1B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60F848A-763C-2416-69E5-D43B48DAB0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CE04F2-B788-495D-8993-0CEE5099057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643614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4AE5F9E-6EA3-210E-6366-2FFBBD1378F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867873C-7D1E-3940-1737-9CE4AF50862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553F6E5-FBD9-97E1-4ADF-73AAF455718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45CC541-7196-86D9-C537-66ABE80C759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F75EA06-E6E7-919F-34FB-F24622890FE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D60407F-EC0C-3CAA-42E6-BDA999F240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3D8F94-3C42-4A5D-9001-2E53EE8BFA5E}" type="datetimeFigureOut">
              <a:rPr lang="en-GB" smtClean="0"/>
              <a:t>16/04/2025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EE0E677-5DB4-D72A-4073-3C64DBB99B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08545A2-D36A-E135-D84F-CAC6A21871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CE04F2-B788-495D-8993-0CEE5099057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869924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9334F76-978B-B059-9D4C-970000B4D6D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693A1E4-C541-B8F5-7876-7F097BCF92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3D8F94-3C42-4A5D-9001-2E53EE8BFA5E}" type="datetimeFigureOut">
              <a:rPr lang="en-GB" smtClean="0"/>
              <a:t>16/04/2025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97B11C9-0B2D-E185-77E6-028ADEB154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8D26A58-EEAC-6A37-D590-5FB8DA9557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CE04F2-B788-495D-8993-0CEE5099057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212998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B6D6839-8AD2-89B4-B9C6-8B4911D80D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3D8F94-3C42-4A5D-9001-2E53EE8BFA5E}" type="datetimeFigureOut">
              <a:rPr lang="en-GB" smtClean="0"/>
              <a:t>16/04/2025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0EDB80C-C2FC-30F7-FBF3-1FF2AE5FFC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9CC3DFF-B4A0-83AE-CECE-6DA7EB4919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CE04F2-B788-495D-8993-0CEE5099057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828233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8B336F2-5C01-9202-7FC3-496BE6ECAD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D1038EC-EE71-D826-00C1-127C1912E83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869C070-5AD0-5686-7488-C5A2E067315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ECC0725-2FA4-8989-8704-B02C5F6AE5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3D8F94-3C42-4A5D-9001-2E53EE8BFA5E}" type="datetimeFigureOut">
              <a:rPr lang="en-GB" smtClean="0"/>
              <a:t>16/04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ABA1F27-6D56-EEAE-9763-9C5BA2EAFB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08CBA49-9C55-E23C-BF62-3AD6ECA148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CE04F2-B788-495D-8993-0CEE5099057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501728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C72A002-41DA-64DB-E71F-81EDCEEE83B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170301C-CFF1-15D7-574B-AE8CFFD4F3C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5A3BA76-E7B9-004A-FDEB-84DB25E0F15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6DE87AB-E86E-05C0-9629-DEF021066F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3D8F94-3C42-4A5D-9001-2E53EE8BFA5E}" type="datetimeFigureOut">
              <a:rPr lang="en-GB" smtClean="0"/>
              <a:t>16/04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5781401-08D9-EEBB-15FE-44C1502CE9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020B896-9176-F3BB-BB44-C202EBFC6B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CE04F2-B788-495D-8993-0CEE5099057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517967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420EC9A-85ED-C94E-C50B-235B5367ADF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42950E7-15B6-29E2-547C-EAC0209FDBF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01D4082-A716-6820-57CB-204D5B59609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A3D8F94-3C42-4A5D-9001-2E53EE8BFA5E}" type="datetimeFigureOut">
              <a:rPr lang="en-GB" smtClean="0"/>
              <a:t>16/04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44BA500-E09B-AAA6-F451-089D2E5B5FE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D822F17-DE1A-CA9F-E725-110D98996C2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4CE04F2-B788-495D-8993-0CEE5099057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143767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TextBox 21">
            <a:extLst>
              <a:ext uri="{FF2B5EF4-FFF2-40B4-BE49-F238E27FC236}">
                <a16:creationId xmlns:a16="http://schemas.microsoft.com/office/drawing/2014/main" id="{F6628C69-8D3E-441C-BF0F-1960CAF1A09F}"/>
              </a:ext>
            </a:extLst>
          </p:cNvPr>
          <p:cNvSpPr txBox="1"/>
          <p:nvPr/>
        </p:nvSpPr>
        <p:spPr>
          <a:xfrm>
            <a:off x="2836504" y="3478928"/>
            <a:ext cx="5792587" cy="648000"/>
          </a:xfrm>
          <a:prstGeom prst="rect">
            <a:avLst/>
          </a:prstGeom>
          <a:solidFill>
            <a:schemeClr val="accent6">
              <a:lumMod val="20000"/>
              <a:lumOff val="80000"/>
            </a:schemeClr>
          </a:solidFill>
        </p:spPr>
        <p:txBody>
          <a:bodyPr wrap="square" rtlCol="0">
            <a:spAutoFit/>
          </a:bodyPr>
          <a:lstStyle/>
          <a:p>
            <a:endParaRPr lang="en-GB" dirty="0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F5E56299-1C37-4630-8A0B-4EBBF6D5D8D7}"/>
              </a:ext>
            </a:extLst>
          </p:cNvPr>
          <p:cNvSpPr txBox="1"/>
          <p:nvPr/>
        </p:nvSpPr>
        <p:spPr>
          <a:xfrm>
            <a:off x="2836504" y="2866928"/>
            <a:ext cx="5796000" cy="612000"/>
          </a:xfrm>
          <a:prstGeom prst="rect">
            <a:avLst/>
          </a:prstGeom>
          <a:solidFill>
            <a:schemeClr val="tx2">
              <a:lumMod val="10000"/>
              <a:lumOff val="90000"/>
            </a:schemeClr>
          </a:solidFill>
        </p:spPr>
        <p:txBody>
          <a:bodyPr wrap="square" rtlCol="0">
            <a:spAutoFit/>
          </a:bodyPr>
          <a:lstStyle/>
          <a:p>
            <a:endParaRPr lang="en-GB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59F462DF-3EDF-41E9-9FEE-37B58C6426AE}"/>
              </a:ext>
            </a:extLst>
          </p:cNvPr>
          <p:cNvSpPr txBox="1"/>
          <p:nvPr/>
        </p:nvSpPr>
        <p:spPr>
          <a:xfrm>
            <a:off x="2836504" y="2254928"/>
            <a:ext cx="5792588" cy="612000"/>
          </a:xfrm>
          <a:prstGeom prst="rect">
            <a:avLst/>
          </a:prstGeom>
          <a:solidFill>
            <a:schemeClr val="accent2">
              <a:lumMod val="20000"/>
              <a:lumOff val="80000"/>
            </a:schemeClr>
          </a:solidFill>
        </p:spPr>
        <p:txBody>
          <a:bodyPr wrap="square" rtlCol="0">
            <a:spAutoFit/>
          </a:bodyPr>
          <a:lstStyle/>
          <a:p>
            <a:endParaRPr lang="en-GB" dirty="0"/>
          </a:p>
        </p:txBody>
      </p:sp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EFD7F214-3596-4905-6AF9-19AF3A8306B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77065733"/>
              </p:ext>
            </p:extLst>
          </p:nvPr>
        </p:nvGraphicFramePr>
        <p:xfrm>
          <a:off x="2534602" y="1665922"/>
          <a:ext cx="6218781" cy="304812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AF78E0A6-E2AD-4F26-90FC-DC144844A108}"/>
              </a:ext>
            </a:extLst>
          </p:cNvPr>
          <p:cNvSpPr txBox="1"/>
          <p:nvPr/>
        </p:nvSpPr>
        <p:spPr>
          <a:xfrm>
            <a:off x="2836507" y="2127868"/>
            <a:ext cx="5792588" cy="127060"/>
          </a:xfrm>
          <a:prstGeom prst="rect">
            <a:avLst/>
          </a:prstGeom>
          <a:solidFill>
            <a:srgbClr val="CC0000">
              <a:alpha val="33000"/>
            </a:srgbClr>
          </a:solidFill>
        </p:spPr>
        <p:txBody>
          <a:bodyPr wrap="square" rtlCol="0">
            <a:spAutoFit/>
          </a:bodyPr>
          <a:lstStyle/>
          <a:p>
            <a:endParaRPr lang="en-GB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085DDD3D-F315-445B-9568-E90CFD33914D}"/>
              </a:ext>
            </a:extLst>
          </p:cNvPr>
          <p:cNvSpPr txBox="1"/>
          <p:nvPr/>
        </p:nvSpPr>
        <p:spPr>
          <a:xfrm>
            <a:off x="2836505" y="2083676"/>
            <a:ext cx="199675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Moderately severe depression</a:t>
            </a:r>
            <a:endParaRPr lang="en-GB" sz="800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E8D9DF86-DF64-4532-A5D2-A6D8261FF146}"/>
              </a:ext>
            </a:extLst>
          </p:cNvPr>
          <p:cNvSpPr txBox="1"/>
          <p:nvPr/>
        </p:nvSpPr>
        <p:spPr>
          <a:xfrm>
            <a:off x="7907440" y="2716874"/>
            <a:ext cx="111154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Clinical cut-off</a:t>
            </a:r>
            <a:endParaRPr lang="en-GB" sz="800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A2D9020E-B7C6-43D2-877C-9117F3BE012E}"/>
              </a:ext>
            </a:extLst>
          </p:cNvPr>
          <p:cNvSpPr txBox="1"/>
          <p:nvPr/>
        </p:nvSpPr>
        <p:spPr>
          <a:xfrm>
            <a:off x="2836507" y="2545622"/>
            <a:ext cx="199675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Moderate depression</a:t>
            </a:r>
            <a:endParaRPr lang="en-GB" sz="800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2B070472-68D8-4D94-8310-2B1F6ADE222D}"/>
              </a:ext>
            </a:extLst>
          </p:cNvPr>
          <p:cNvSpPr txBox="1"/>
          <p:nvPr/>
        </p:nvSpPr>
        <p:spPr>
          <a:xfrm>
            <a:off x="2836506" y="3123694"/>
            <a:ext cx="199675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Mild depression</a:t>
            </a:r>
            <a:endParaRPr lang="en-GB" sz="800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78623330-913D-43F6-A846-267E5ED9347A}"/>
              </a:ext>
            </a:extLst>
          </p:cNvPr>
          <p:cNvSpPr txBox="1"/>
          <p:nvPr/>
        </p:nvSpPr>
        <p:spPr>
          <a:xfrm>
            <a:off x="2836504" y="3629832"/>
            <a:ext cx="199675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Minimal depression</a:t>
            </a:r>
            <a:endParaRPr lang="en-GB" sz="800" dirty="0"/>
          </a:p>
        </p:txBody>
      </p: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E893EE52-CE64-4728-B59F-458BFF637160}"/>
              </a:ext>
            </a:extLst>
          </p:cNvPr>
          <p:cNvCxnSpPr>
            <a:cxnSpLocks/>
          </p:cNvCxnSpPr>
          <p:nvPr/>
        </p:nvCxnSpPr>
        <p:spPr>
          <a:xfrm>
            <a:off x="2927927" y="2866928"/>
            <a:ext cx="387928" cy="0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53691F7C-65F6-402A-A94B-37A67C9D4B5E}"/>
              </a:ext>
            </a:extLst>
          </p:cNvPr>
          <p:cNvCxnSpPr>
            <a:cxnSpLocks/>
          </p:cNvCxnSpPr>
          <p:nvPr/>
        </p:nvCxnSpPr>
        <p:spPr>
          <a:xfrm>
            <a:off x="3579091" y="2866928"/>
            <a:ext cx="387928" cy="0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6" name="Straight Connector 15">
            <a:extLst>
              <a:ext uri="{FF2B5EF4-FFF2-40B4-BE49-F238E27FC236}">
                <a16:creationId xmlns:a16="http://schemas.microsoft.com/office/drawing/2014/main" id="{0ED033D2-F711-4B7E-8B64-6EBBD100B7C3}"/>
              </a:ext>
            </a:extLst>
          </p:cNvPr>
          <p:cNvCxnSpPr>
            <a:cxnSpLocks/>
          </p:cNvCxnSpPr>
          <p:nvPr/>
        </p:nvCxnSpPr>
        <p:spPr>
          <a:xfrm>
            <a:off x="4313382" y="2866928"/>
            <a:ext cx="387928" cy="0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81265A8A-E7A1-4FAB-A87F-86FCF0DF1B2E}"/>
              </a:ext>
            </a:extLst>
          </p:cNvPr>
          <p:cNvCxnSpPr>
            <a:cxnSpLocks/>
          </p:cNvCxnSpPr>
          <p:nvPr/>
        </p:nvCxnSpPr>
        <p:spPr>
          <a:xfrm>
            <a:off x="5795818" y="2866928"/>
            <a:ext cx="387928" cy="0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0F7A6DB7-084B-4DE0-B480-AA3C26CF1C8F}"/>
              </a:ext>
            </a:extLst>
          </p:cNvPr>
          <p:cNvCxnSpPr>
            <a:cxnSpLocks/>
          </p:cNvCxnSpPr>
          <p:nvPr/>
        </p:nvCxnSpPr>
        <p:spPr>
          <a:xfrm>
            <a:off x="6733308" y="2866928"/>
            <a:ext cx="387928" cy="0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E47F88E8-AC48-438E-9C03-879F15D8CD0B}"/>
              </a:ext>
            </a:extLst>
          </p:cNvPr>
          <p:cNvCxnSpPr>
            <a:cxnSpLocks/>
          </p:cNvCxnSpPr>
          <p:nvPr/>
        </p:nvCxnSpPr>
        <p:spPr>
          <a:xfrm>
            <a:off x="7519512" y="2866928"/>
            <a:ext cx="387928" cy="0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91448607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Override1.xml><?xml version="1.0" encoding="utf-8"?>
<a:themeOverride xmlns:a="http://schemas.openxmlformats.org/drawingml/2006/main">
  <a:clrScheme name="Red Orange">
    <a:dk1>
      <a:sysClr val="windowText" lastClr="000000"/>
    </a:dk1>
    <a:lt1>
      <a:sysClr val="window" lastClr="FFFFFF"/>
    </a:lt1>
    <a:dk2>
      <a:srgbClr val="505046"/>
    </a:dk2>
    <a:lt2>
      <a:srgbClr val="EEECE1"/>
    </a:lt2>
    <a:accent1>
      <a:srgbClr val="E84C22"/>
    </a:accent1>
    <a:accent2>
      <a:srgbClr val="FFBD47"/>
    </a:accent2>
    <a:accent3>
      <a:srgbClr val="B64926"/>
    </a:accent3>
    <a:accent4>
      <a:srgbClr val="FF8427"/>
    </a:accent4>
    <a:accent5>
      <a:srgbClr val="CC9900"/>
    </a:accent5>
    <a:accent6>
      <a:srgbClr val="B22600"/>
    </a:accent6>
    <a:hlink>
      <a:srgbClr val="CC9900"/>
    </a:hlink>
    <a:folHlink>
      <a:srgbClr val="666699"/>
    </a:folHlink>
  </a:clrScheme>
  <a:fontScheme name="Office">
    <a:majorFont>
      <a:latin typeface="Aptos Display" panose="0211000402020202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Aptos Narrow" panose="02110004020202020204"/>
      <a:ea typeface=""/>
      <a:cs typeface=""/>
      <a:font script="Jpan" typeface="游ゴシック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  <a:ln w="2540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50</TotalTime>
  <Words>22</Words>
  <Application>Microsoft Office PowerPoint</Application>
  <PresentationFormat>Widescreen</PresentationFormat>
  <Paragraphs>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bbie Stark</dc:creator>
  <cp:lastModifiedBy>Abbie Stark (Aneurin Bevan UHB - Learning Disabilities)</cp:lastModifiedBy>
  <cp:revision>2</cp:revision>
  <dcterms:created xsi:type="dcterms:W3CDTF">2024-04-08T12:56:15Z</dcterms:created>
  <dcterms:modified xsi:type="dcterms:W3CDTF">2025-04-16T10:05:30Z</dcterms:modified>
</cp:coreProperties>
</file>